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>
    <p:restoredLeft sz="15620"/>
    <p:restoredTop sz="98746" autoAdjust="0"/>
  </p:normalViewPr>
  <p:slideViewPr>
    <p:cSldViewPr snapToGrid="0" snapToObjects="1" showGuides="1">
      <p:cViewPr>
        <p:scale>
          <a:sx n="200" d="100"/>
          <a:sy n="200" d="100"/>
        </p:scale>
        <p:origin x="-336" y="67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7AAA0-A79B-A14D-8FB9-9C73F5D260CC}" type="datetimeFigureOut">
              <a:rPr lang="en-US" smtClean="0"/>
              <a:pPr/>
              <a:t>9/1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ED211-8D79-C142-B8F7-9CCB7B0BD9E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Freeform 8"/>
          <p:cNvSpPr/>
          <p:nvPr/>
        </p:nvSpPr>
        <p:spPr>
          <a:xfrm>
            <a:off x="3536146" y="693380"/>
            <a:ext cx="1661556" cy="437643"/>
          </a:xfrm>
          <a:custGeom>
            <a:avLst/>
            <a:gdLst>
              <a:gd name="connsiteX0" fmla="*/ 0 w 1896534"/>
              <a:gd name="connsiteY0" fmla="*/ 118533 h 499533"/>
              <a:gd name="connsiteX1" fmla="*/ 101600 w 1896534"/>
              <a:gd name="connsiteY1" fmla="*/ 448733 h 499533"/>
              <a:gd name="connsiteX2" fmla="*/ 296334 w 1896534"/>
              <a:gd name="connsiteY2" fmla="*/ 423333 h 499533"/>
              <a:gd name="connsiteX3" fmla="*/ 457200 w 1896534"/>
              <a:gd name="connsiteY3" fmla="*/ 228599 h 499533"/>
              <a:gd name="connsiteX4" fmla="*/ 711200 w 1896534"/>
              <a:gd name="connsiteY4" fmla="*/ 177799 h 499533"/>
              <a:gd name="connsiteX5" fmla="*/ 1016000 w 1896534"/>
              <a:gd name="connsiteY5" fmla="*/ 76199 h 499533"/>
              <a:gd name="connsiteX6" fmla="*/ 1371600 w 1896534"/>
              <a:gd name="connsiteY6" fmla="*/ 16933 h 499533"/>
              <a:gd name="connsiteX7" fmla="*/ 1634067 w 1896534"/>
              <a:gd name="connsiteY7" fmla="*/ 177799 h 499533"/>
              <a:gd name="connsiteX8" fmla="*/ 1896534 w 1896534"/>
              <a:gd name="connsiteY8" fmla="*/ 143933 h 4995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896534" h="499533">
                <a:moveTo>
                  <a:pt x="0" y="118533"/>
                </a:moveTo>
                <a:cubicBezTo>
                  <a:pt x="26105" y="258233"/>
                  <a:pt x="52211" y="397933"/>
                  <a:pt x="101600" y="448733"/>
                </a:cubicBezTo>
                <a:cubicBezTo>
                  <a:pt x="150989" y="499533"/>
                  <a:pt x="237068" y="460022"/>
                  <a:pt x="296334" y="423333"/>
                </a:cubicBezTo>
                <a:cubicBezTo>
                  <a:pt x="355600" y="386644"/>
                  <a:pt x="388056" y="269521"/>
                  <a:pt x="457200" y="228599"/>
                </a:cubicBezTo>
                <a:cubicBezTo>
                  <a:pt x="526344" y="187677"/>
                  <a:pt x="618067" y="203199"/>
                  <a:pt x="711200" y="177799"/>
                </a:cubicBezTo>
                <a:cubicBezTo>
                  <a:pt x="804333" y="152399"/>
                  <a:pt x="905933" y="103010"/>
                  <a:pt x="1016000" y="76199"/>
                </a:cubicBezTo>
                <a:cubicBezTo>
                  <a:pt x="1126067" y="49388"/>
                  <a:pt x="1268589" y="0"/>
                  <a:pt x="1371600" y="16933"/>
                </a:cubicBezTo>
                <a:cubicBezTo>
                  <a:pt x="1474611" y="33866"/>
                  <a:pt x="1546578" y="156632"/>
                  <a:pt x="1634067" y="177799"/>
                </a:cubicBezTo>
                <a:cubicBezTo>
                  <a:pt x="1721556" y="198966"/>
                  <a:pt x="1896534" y="143933"/>
                  <a:pt x="1896534" y="143933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reeform 15"/>
          <p:cNvSpPr/>
          <p:nvPr/>
        </p:nvSpPr>
        <p:spPr>
          <a:xfrm>
            <a:off x="4007758" y="1159457"/>
            <a:ext cx="1179407" cy="3236579"/>
          </a:xfrm>
          <a:custGeom>
            <a:avLst/>
            <a:gdLst>
              <a:gd name="connsiteX0" fmla="*/ 0 w 1346200"/>
              <a:gd name="connsiteY0" fmla="*/ 201789 h 3694289"/>
              <a:gd name="connsiteX1" fmla="*/ 228600 w 1346200"/>
              <a:gd name="connsiteY1" fmla="*/ 57856 h 3694289"/>
              <a:gd name="connsiteX2" fmla="*/ 338667 w 1346200"/>
              <a:gd name="connsiteY2" fmla="*/ 227189 h 3694289"/>
              <a:gd name="connsiteX3" fmla="*/ 304800 w 1346200"/>
              <a:gd name="connsiteY3" fmla="*/ 574323 h 3694289"/>
              <a:gd name="connsiteX4" fmla="*/ 355600 w 1346200"/>
              <a:gd name="connsiteY4" fmla="*/ 1150056 h 3694289"/>
              <a:gd name="connsiteX5" fmla="*/ 338667 w 1346200"/>
              <a:gd name="connsiteY5" fmla="*/ 1776589 h 3694289"/>
              <a:gd name="connsiteX6" fmla="*/ 296333 w 1346200"/>
              <a:gd name="connsiteY6" fmla="*/ 2377723 h 3694289"/>
              <a:gd name="connsiteX7" fmla="*/ 355600 w 1346200"/>
              <a:gd name="connsiteY7" fmla="*/ 3012723 h 3694289"/>
              <a:gd name="connsiteX8" fmla="*/ 423333 w 1346200"/>
              <a:gd name="connsiteY8" fmla="*/ 3588456 h 3694289"/>
              <a:gd name="connsiteX9" fmla="*/ 618067 w 1346200"/>
              <a:gd name="connsiteY9" fmla="*/ 3647723 h 3694289"/>
              <a:gd name="connsiteX10" fmla="*/ 643467 w 1346200"/>
              <a:gd name="connsiteY10" fmla="*/ 3334456 h 3694289"/>
              <a:gd name="connsiteX11" fmla="*/ 558800 w 1346200"/>
              <a:gd name="connsiteY11" fmla="*/ 3029656 h 3694289"/>
              <a:gd name="connsiteX12" fmla="*/ 660400 w 1346200"/>
              <a:gd name="connsiteY12" fmla="*/ 2521656 h 3694289"/>
              <a:gd name="connsiteX13" fmla="*/ 651933 w 1346200"/>
              <a:gd name="connsiteY13" fmla="*/ 1844323 h 3694289"/>
              <a:gd name="connsiteX14" fmla="*/ 643467 w 1346200"/>
              <a:gd name="connsiteY14" fmla="*/ 1420989 h 3694289"/>
              <a:gd name="connsiteX15" fmla="*/ 618067 w 1346200"/>
              <a:gd name="connsiteY15" fmla="*/ 972256 h 3694289"/>
              <a:gd name="connsiteX16" fmla="*/ 618067 w 1346200"/>
              <a:gd name="connsiteY16" fmla="*/ 531989 h 3694289"/>
              <a:gd name="connsiteX17" fmla="*/ 584200 w 1346200"/>
              <a:gd name="connsiteY17" fmla="*/ 193323 h 3694289"/>
              <a:gd name="connsiteX18" fmla="*/ 711200 w 1346200"/>
              <a:gd name="connsiteY18" fmla="*/ 23989 h 3694289"/>
              <a:gd name="connsiteX19" fmla="*/ 948267 w 1346200"/>
              <a:gd name="connsiteY19" fmla="*/ 74789 h 3694289"/>
              <a:gd name="connsiteX20" fmla="*/ 914400 w 1346200"/>
              <a:gd name="connsiteY20" fmla="*/ 472723 h 3694289"/>
              <a:gd name="connsiteX21" fmla="*/ 990600 w 1346200"/>
              <a:gd name="connsiteY21" fmla="*/ 1166989 h 3694289"/>
              <a:gd name="connsiteX22" fmla="*/ 1193800 w 1346200"/>
              <a:gd name="connsiteY22" fmla="*/ 1768123 h 3694289"/>
              <a:gd name="connsiteX23" fmla="*/ 1320800 w 1346200"/>
              <a:gd name="connsiteY23" fmla="*/ 1708856 h 3694289"/>
              <a:gd name="connsiteX24" fmla="*/ 1346200 w 1346200"/>
              <a:gd name="connsiteY24" fmla="*/ 1361723 h 36942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1346200" h="3694289">
                <a:moveTo>
                  <a:pt x="0" y="201789"/>
                </a:moveTo>
                <a:cubicBezTo>
                  <a:pt x="86077" y="127706"/>
                  <a:pt x="172155" y="53623"/>
                  <a:pt x="228600" y="57856"/>
                </a:cubicBezTo>
                <a:cubicBezTo>
                  <a:pt x="285045" y="62089"/>
                  <a:pt x="325967" y="141111"/>
                  <a:pt x="338667" y="227189"/>
                </a:cubicBezTo>
                <a:cubicBezTo>
                  <a:pt x="351367" y="313267"/>
                  <a:pt x="301978" y="420512"/>
                  <a:pt x="304800" y="574323"/>
                </a:cubicBezTo>
                <a:cubicBezTo>
                  <a:pt x="307622" y="728134"/>
                  <a:pt x="349956" y="949678"/>
                  <a:pt x="355600" y="1150056"/>
                </a:cubicBezTo>
                <a:cubicBezTo>
                  <a:pt x="361244" y="1350434"/>
                  <a:pt x="348545" y="1571978"/>
                  <a:pt x="338667" y="1776589"/>
                </a:cubicBezTo>
                <a:cubicBezTo>
                  <a:pt x="328789" y="1981200"/>
                  <a:pt x="293511" y="2171701"/>
                  <a:pt x="296333" y="2377723"/>
                </a:cubicBezTo>
                <a:cubicBezTo>
                  <a:pt x="299155" y="2583745"/>
                  <a:pt x="334433" y="2810934"/>
                  <a:pt x="355600" y="3012723"/>
                </a:cubicBezTo>
                <a:cubicBezTo>
                  <a:pt x="376767" y="3214512"/>
                  <a:pt x="379589" y="3482623"/>
                  <a:pt x="423333" y="3588456"/>
                </a:cubicBezTo>
                <a:cubicBezTo>
                  <a:pt x="467077" y="3694289"/>
                  <a:pt x="581378" y="3690056"/>
                  <a:pt x="618067" y="3647723"/>
                </a:cubicBezTo>
                <a:cubicBezTo>
                  <a:pt x="654756" y="3605390"/>
                  <a:pt x="653345" y="3437467"/>
                  <a:pt x="643467" y="3334456"/>
                </a:cubicBezTo>
                <a:cubicBezTo>
                  <a:pt x="633589" y="3231445"/>
                  <a:pt x="555978" y="3165123"/>
                  <a:pt x="558800" y="3029656"/>
                </a:cubicBezTo>
                <a:cubicBezTo>
                  <a:pt x="561622" y="2894189"/>
                  <a:pt x="644878" y="2719211"/>
                  <a:pt x="660400" y="2521656"/>
                </a:cubicBezTo>
                <a:cubicBezTo>
                  <a:pt x="675922" y="2324101"/>
                  <a:pt x="654755" y="2027767"/>
                  <a:pt x="651933" y="1844323"/>
                </a:cubicBezTo>
                <a:cubicBezTo>
                  <a:pt x="649111" y="1660879"/>
                  <a:pt x="649111" y="1566333"/>
                  <a:pt x="643467" y="1420989"/>
                </a:cubicBezTo>
                <a:cubicBezTo>
                  <a:pt x="637823" y="1275645"/>
                  <a:pt x="622300" y="1120423"/>
                  <a:pt x="618067" y="972256"/>
                </a:cubicBezTo>
                <a:cubicBezTo>
                  <a:pt x="613834" y="824089"/>
                  <a:pt x="623711" y="661811"/>
                  <a:pt x="618067" y="531989"/>
                </a:cubicBezTo>
                <a:cubicBezTo>
                  <a:pt x="612423" y="402167"/>
                  <a:pt x="568678" y="277990"/>
                  <a:pt x="584200" y="193323"/>
                </a:cubicBezTo>
                <a:cubicBezTo>
                  <a:pt x="599722" y="108656"/>
                  <a:pt x="650522" y="43745"/>
                  <a:pt x="711200" y="23989"/>
                </a:cubicBezTo>
                <a:cubicBezTo>
                  <a:pt x="771878" y="4233"/>
                  <a:pt x="914400" y="0"/>
                  <a:pt x="948267" y="74789"/>
                </a:cubicBezTo>
                <a:cubicBezTo>
                  <a:pt x="982134" y="149578"/>
                  <a:pt x="907344" y="290690"/>
                  <a:pt x="914400" y="472723"/>
                </a:cubicBezTo>
                <a:cubicBezTo>
                  <a:pt x="921456" y="654756"/>
                  <a:pt x="944033" y="951089"/>
                  <a:pt x="990600" y="1166989"/>
                </a:cubicBezTo>
                <a:cubicBezTo>
                  <a:pt x="1037167" y="1382889"/>
                  <a:pt x="1138767" y="1677812"/>
                  <a:pt x="1193800" y="1768123"/>
                </a:cubicBezTo>
                <a:cubicBezTo>
                  <a:pt x="1248833" y="1858434"/>
                  <a:pt x="1295400" y="1776589"/>
                  <a:pt x="1320800" y="1708856"/>
                </a:cubicBezTo>
                <a:cubicBezTo>
                  <a:pt x="1346200" y="1641123"/>
                  <a:pt x="1346200" y="1361723"/>
                  <a:pt x="1346200" y="1361723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FF"/>
              </a:solidFill>
            </a:endParaRPr>
          </a:p>
        </p:txBody>
      </p:sp>
      <p:sp>
        <p:nvSpPr>
          <p:cNvPr id="17" name="Freeform 16"/>
          <p:cNvSpPr/>
          <p:nvPr/>
        </p:nvSpPr>
        <p:spPr>
          <a:xfrm>
            <a:off x="4571501" y="2307961"/>
            <a:ext cx="373355" cy="1671449"/>
          </a:xfrm>
          <a:custGeom>
            <a:avLst/>
            <a:gdLst>
              <a:gd name="connsiteX0" fmla="*/ 220133 w 426155"/>
              <a:gd name="connsiteY0" fmla="*/ 93133 h 1907822"/>
              <a:gd name="connsiteX1" fmla="*/ 338666 w 426155"/>
              <a:gd name="connsiteY1" fmla="*/ 694266 h 1907822"/>
              <a:gd name="connsiteX2" fmla="*/ 423333 w 426155"/>
              <a:gd name="connsiteY2" fmla="*/ 1363133 h 1907822"/>
              <a:gd name="connsiteX3" fmla="*/ 321733 w 426155"/>
              <a:gd name="connsiteY3" fmla="*/ 1794933 h 1907822"/>
              <a:gd name="connsiteX4" fmla="*/ 143933 w 426155"/>
              <a:gd name="connsiteY4" fmla="*/ 1854200 h 1907822"/>
              <a:gd name="connsiteX5" fmla="*/ 16933 w 426155"/>
              <a:gd name="connsiteY5" fmla="*/ 1473200 h 1907822"/>
              <a:gd name="connsiteX6" fmla="*/ 42333 w 426155"/>
              <a:gd name="connsiteY6" fmla="*/ 889000 h 1907822"/>
              <a:gd name="connsiteX7" fmla="*/ 59266 w 426155"/>
              <a:gd name="connsiteY7" fmla="*/ 0 h 190782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426155" h="1907822">
                <a:moveTo>
                  <a:pt x="220133" y="93133"/>
                </a:moveTo>
                <a:cubicBezTo>
                  <a:pt x="262466" y="287866"/>
                  <a:pt x="304799" y="482599"/>
                  <a:pt x="338666" y="694266"/>
                </a:cubicBezTo>
                <a:cubicBezTo>
                  <a:pt x="372533" y="905933"/>
                  <a:pt x="426155" y="1179689"/>
                  <a:pt x="423333" y="1363133"/>
                </a:cubicBezTo>
                <a:cubicBezTo>
                  <a:pt x="420511" y="1546577"/>
                  <a:pt x="368300" y="1713089"/>
                  <a:pt x="321733" y="1794933"/>
                </a:cubicBezTo>
                <a:cubicBezTo>
                  <a:pt x="275166" y="1876778"/>
                  <a:pt x="194733" y="1907822"/>
                  <a:pt x="143933" y="1854200"/>
                </a:cubicBezTo>
                <a:cubicBezTo>
                  <a:pt x="93133" y="1800578"/>
                  <a:pt x="33866" y="1634067"/>
                  <a:pt x="16933" y="1473200"/>
                </a:cubicBezTo>
                <a:cubicBezTo>
                  <a:pt x="0" y="1312333"/>
                  <a:pt x="35278" y="1134533"/>
                  <a:pt x="42333" y="889000"/>
                </a:cubicBezTo>
                <a:cubicBezTo>
                  <a:pt x="49389" y="643467"/>
                  <a:pt x="59266" y="0"/>
                  <a:pt x="59266" y="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FF"/>
              </a:solidFill>
            </a:endParaRPr>
          </a:p>
        </p:txBody>
      </p:sp>
      <p:sp>
        <p:nvSpPr>
          <p:cNvPr id="18" name="Freeform 17"/>
          <p:cNvSpPr/>
          <p:nvPr/>
        </p:nvSpPr>
        <p:spPr>
          <a:xfrm>
            <a:off x="3751849" y="1336245"/>
            <a:ext cx="546434" cy="2890421"/>
          </a:xfrm>
          <a:custGeom>
            <a:avLst/>
            <a:gdLst>
              <a:gd name="connsiteX0" fmla="*/ 38100 w 623711"/>
              <a:gd name="connsiteY0" fmla="*/ 228600 h 3299178"/>
              <a:gd name="connsiteX1" fmla="*/ 12700 w 623711"/>
              <a:gd name="connsiteY1" fmla="*/ 770467 h 3299178"/>
              <a:gd name="connsiteX2" fmla="*/ 114300 w 623711"/>
              <a:gd name="connsiteY2" fmla="*/ 1498600 h 3299178"/>
              <a:gd name="connsiteX3" fmla="*/ 156633 w 623711"/>
              <a:gd name="connsiteY3" fmla="*/ 2175934 h 3299178"/>
              <a:gd name="connsiteX4" fmla="*/ 232833 w 623711"/>
              <a:gd name="connsiteY4" fmla="*/ 3022600 h 3299178"/>
              <a:gd name="connsiteX5" fmla="*/ 486833 w 623711"/>
              <a:gd name="connsiteY5" fmla="*/ 3268134 h 3299178"/>
              <a:gd name="connsiteX6" fmla="*/ 622300 w 623711"/>
              <a:gd name="connsiteY6" fmla="*/ 2836334 h 3299178"/>
              <a:gd name="connsiteX7" fmla="*/ 478367 w 623711"/>
              <a:gd name="connsiteY7" fmla="*/ 2091267 h 3299178"/>
              <a:gd name="connsiteX8" fmla="*/ 393700 w 623711"/>
              <a:gd name="connsiteY8" fmla="*/ 1761067 h 3299178"/>
              <a:gd name="connsiteX9" fmla="*/ 393700 w 623711"/>
              <a:gd name="connsiteY9" fmla="*/ 1185334 h 3299178"/>
              <a:gd name="connsiteX10" fmla="*/ 351367 w 623711"/>
              <a:gd name="connsiteY10" fmla="*/ 618067 h 3299178"/>
              <a:gd name="connsiteX11" fmla="*/ 317500 w 623711"/>
              <a:gd name="connsiteY11" fmla="*/ 118534 h 3299178"/>
              <a:gd name="connsiteX12" fmla="*/ 283633 w 623711"/>
              <a:gd name="connsiteY12" fmla="*/ 0 h 32991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623711" h="3299178">
                <a:moveTo>
                  <a:pt x="38100" y="228600"/>
                </a:moveTo>
                <a:cubicBezTo>
                  <a:pt x="19050" y="393700"/>
                  <a:pt x="0" y="558800"/>
                  <a:pt x="12700" y="770467"/>
                </a:cubicBezTo>
                <a:cubicBezTo>
                  <a:pt x="25400" y="982134"/>
                  <a:pt x="90311" y="1264356"/>
                  <a:pt x="114300" y="1498600"/>
                </a:cubicBezTo>
                <a:cubicBezTo>
                  <a:pt x="138289" y="1732844"/>
                  <a:pt x="136878" y="1921934"/>
                  <a:pt x="156633" y="2175934"/>
                </a:cubicBezTo>
                <a:cubicBezTo>
                  <a:pt x="176388" y="2429934"/>
                  <a:pt x="177800" y="2840567"/>
                  <a:pt x="232833" y="3022600"/>
                </a:cubicBezTo>
                <a:cubicBezTo>
                  <a:pt x="287866" y="3204633"/>
                  <a:pt x="421922" y="3299178"/>
                  <a:pt x="486833" y="3268134"/>
                </a:cubicBezTo>
                <a:cubicBezTo>
                  <a:pt x="551744" y="3237090"/>
                  <a:pt x="623711" y="3032478"/>
                  <a:pt x="622300" y="2836334"/>
                </a:cubicBezTo>
                <a:cubicBezTo>
                  <a:pt x="620889" y="2640190"/>
                  <a:pt x="516467" y="2270478"/>
                  <a:pt x="478367" y="2091267"/>
                </a:cubicBezTo>
                <a:cubicBezTo>
                  <a:pt x="440267" y="1912056"/>
                  <a:pt x="407811" y="1912056"/>
                  <a:pt x="393700" y="1761067"/>
                </a:cubicBezTo>
                <a:cubicBezTo>
                  <a:pt x="379589" y="1610078"/>
                  <a:pt x="400755" y="1375834"/>
                  <a:pt x="393700" y="1185334"/>
                </a:cubicBezTo>
                <a:cubicBezTo>
                  <a:pt x="386645" y="994834"/>
                  <a:pt x="364067" y="795867"/>
                  <a:pt x="351367" y="618067"/>
                </a:cubicBezTo>
                <a:cubicBezTo>
                  <a:pt x="338667" y="440267"/>
                  <a:pt x="328789" y="221545"/>
                  <a:pt x="317500" y="118534"/>
                </a:cubicBezTo>
                <a:cubicBezTo>
                  <a:pt x="306211" y="15523"/>
                  <a:pt x="283633" y="0"/>
                  <a:pt x="283633" y="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FF"/>
              </a:solidFill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 flipV="1">
            <a:off x="5912141" y="3535333"/>
            <a:ext cx="328669" cy="394"/>
          </a:xfrm>
          <a:prstGeom prst="straightConnector1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629995" y="3283132"/>
            <a:ext cx="493688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FFFFFF"/>
                </a:solidFill>
              </a:rPr>
              <a:t>M</a:t>
            </a:r>
            <a:endParaRPr lang="en-US" sz="1100" dirty="0">
              <a:solidFill>
                <a:srgbClr val="FFFFFF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95285" y="8663803"/>
            <a:ext cx="21667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ry </a:t>
            </a:r>
            <a:r>
              <a:rPr lang="en-US" sz="1200" smtClean="0"/>
              <a:t>Figure</a:t>
            </a:r>
            <a:r>
              <a:rPr lang="en-US" sz="1200" smtClean="0"/>
              <a:t> 3</a:t>
            </a:r>
            <a:endParaRPr lang="en-US" sz="1200" dirty="0"/>
          </a:p>
        </p:txBody>
      </p:sp>
      <p:sp>
        <p:nvSpPr>
          <p:cNvPr id="22" name="TextBox 21"/>
          <p:cNvSpPr txBox="1"/>
          <p:nvPr/>
        </p:nvSpPr>
        <p:spPr>
          <a:xfrm>
            <a:off x="596074" y="37484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4011312" y="160684"/>
            <a:ext cx="17917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Human  skin (HF bulb)</a:t>
            </a:r>
            <a:endParaRPr lang="en-US" sz="1400" dirty="0"/>
          </a:p>
        </p:txBody>
      </p:sp>
      <p:cxnSp>
        <p:nvCxnSpPr>
          <p:cNvPr id="26" name="Straight Arrow Connector 25"/>
          <p:cNvCxnSpPr/>
          <p:nvPr/>
        </p:nvCxnSpPr>
        <p:spPr>
          <a:xfrm>
            <a:off x="5756967" y="2108584"/>
            <a:ext cx="291038" cy="1391"/>
          </a:xfrm>
          <a:prstGeom prst="straightConnector1">
            <a:avLst/>
          </a:prstGeom>
          <a:ln w="12700" cap="flat" cmpd="sng" algn="ctr">
            <a:solidFill>
              <a:schemeClr val="bg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606121" y="1845408"/>
            <a:ext cx="417615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rgbClr val="FFFFFF"/>
                </a:solidFill>
              </a:rPr>
              <a:t>ORS</a:t>
            </a:r>
            <a:endParaRPr lang="en-US" sz="1100" dirty="0">
              <a:solidFill>
                <a:srgbClr val="FFFFFF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050093" y="873099"/>
            <a:ext cx="7032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</a:rPr>
              <a:t>epidermis</a:t>
            </a:r>
            <a:endParaRPr lang="en-US" sz="1000" dirty="0">
              <a:solidFill>
                <a:schemeClr val="bg1"/>
              </a:solidFill>
            </a:endParaRPr>
          </a:p>
        </p:txBody>
      </p:sp>
      <p:pic>
        <p:nvPicPr>
          <p:cNvPr id="31" name="Picture 30" descr="SOX10 hu HF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72674" y="430361"/>
            <a:ext cx="2798240" cy="3197990"/>
          </a:xfrm>
          <a:prstGeom prst="rect">
            <a:avLst/>
          </a:prstGeom>
        </p:spPr>
      </p:pic>
      <p:pic>
        <p:nvPicPr>
          <p:cNvPr id="40" name="Picture 39" descr="HF bulb HUMAN for Figure 1.ti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2287" y="352399"/>
            <a:ext cx="2394356" cy="3258984"/>
          </a:xfrm>
          <a:prstGeom prst="rect">
            <a:avLst/>
          </a:prstGeom>
        </p:spPr>
      </p:pic>
      <p:sp>
        <p:nvSpPr>
          <p:cNvPr id="41" name="Freeform 40"/>
          <p:cNvSpPr/>
          <p:nvPr/>
        </p:nvSpPr>
        <p:spPr>
          <a:xfrm>
            <a:off x="3636433" y="457200"/>
            <a:ext cx="2428875" cy="3075517"/>
          </a:xfrm>
          <a:custGeom>
            <a:avLst/>
            <a:gdLst>
              <a:gd name="connsiteX0" fmla="*/ 408517 w 2428875"/>
              <a:gd name="connsiteY0" fmla="*/ 31750 h 3075517"/>
              <a:gd name="connsiteX1" fmla="*/ 313267 w 2428875"/>
              <a:gd name="connsiteY1" fmla="*/ 508000 h 3075517"/>
              <a:gd name="connsiteX2" fmla="*/ 129117 w 2428875"/>
              <a:gd name="connsiteY2" fmla="*/ 1079500 h 3075517"/>
              <a:gd name="connsiteX3" fmla="*/ 14817 w 2428875"/>
              <a:gd name="connsiteY3" fmla="*/ 1530350 h 3075517"/>
              <a:gd name="connsiteX4" fmla="*/ 40217 w 2428875"/>
              <a:gd name="connsiteY4" fmla="*/ 2063750 h 3075517"/>
              <a:gd name="connsiteX5" fmla="*/ 224367 w 2428875"/>
              <a:gd name="connsiteY5" fmla="*/ 2616200 h 3075517"/>
              <a:gd name="connsiteX6" fmla="*/ 605367 w 2428875"/>
              <a:gd name="connsiteY6" fmla="*/ 2921000 h 3075517"/>
              <a:gd name="connsiteX7" fmla="*/ 967317 w 2428875"/>
              <a:gd name="connsiteY7" fmla="*/ 3041650 h 3075517"/>
              <a:gd name="connsiteX8" fmla="*/ 1564217 w 2428875"/>
              <a:gd name="connsiteY8" fmla="*/ 3016250 h 3075517"/>
              <a:gd name="connsiteX9" fmla="*/ 2123017 w 2428875"/>
              <a:gd name="connsiteY9" fmla="*/ 2686050 h 3075517"/>
              <a:gd name="connsiteX10" fmla="*/ 2370667 w 2428875"/>
              <a:gd name="connsiteY10" fmla="*/ 2343150 h 3075517"/>
              <a:gd name="connsiteX11" fmla="*/ 2427817 w 2428875"/>
              <a:gd name="connsiteY11" fmla="*/ 1974850 h 3075517"/>
              <a:gd name="connsiteX12" fmla="*/ 2364317 w 2428875"/>
              <a:gd name="connsiteY12" fmla="*/ 1625600 h 3075517"/>
              <a:gd name="connsiteX13" fmla="*/ 2237317 w 2428875"/>
              <a:gd name="connsiteY13" fmla="*/ 1244600 h 3075517"/>
              <a:gd name="connsiteX14" fmla="*/ 2167467 w 2428875"/>
              <a:gd name="connsiteY14" fmla="*/ 812800 h 3075517"/>
              <a:gd name="connsiteX15" fmla="*/ 2142067 w 2428875"/>
              <a:gd name="connsiteY15" fmla="*/ 450850 h 3075517"/>
              <a:gd name="connsiteX16" fmla="*/ 2078567 w 2428875"/>
              <a:gd name="connsiteY16" fmla="*/ 0 h 30755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2428875" h="3075517">
                <a:moveTo>
                  <a:pt x="408517" y="31750"/>
                </a:moveTo>
                <a:cubicBezTo>
                  <a:pt x="384175" y="182562"/>
                  <a:pt x="359834" y="333375"/>
                  <a:pt x="313267" y="508000"/>
                </a:cubicBezTo>
                <a:cubicBezTo>
                  <a:pt x="266700" y="682625"/>
                  <a:pt x="178859" y="909108"/>
                  <a:pt x="129117" y="1079500"/>
                </a:cubicBezTo>
                <a:cubicBezTo>
                  <a:pt x="79375" y="1249892"/>
                  <a:pt x="29634" y="1366309"/>
                  <a:pt x="14817" y="1530350"/>
                </a:cubicBezTo>
                <a:cubicBezTo>
                  <a:pt x="0" y="1694391"/>
                  <a:pt x="5292" y="1882775"/>
                  <a:pt x="40217" y="2063750"/>
                </a:cubicBezTo>
                <a:cubicBezTo>
                  <a:pt x="75142" y="2244725"/>
                  <a:pt x="130175" y="2473325"/>
                  <a:pt x="224367" y="2616200"/>
                </a:cubicBezTo>
                <a:cubicBezTo>
                  <a:pt x="318559" y="2759075"/>
                  <a:pt x="481542" y="2850092"/>
                  <a:pt x="605367" y="2921000"/>
                </a:cubicBezTo>
                <a:cubicBezTo>
                  <a:pt x="729192" y="2991908"/>
                  <a:pt x="807509" y="3025775"/>
                  <a:pt x="967317" y="3041650"/>
                </a:cubicBezTo>
                <a:cubicBezTo>
                  <a:pt x="1127125" y="3057525"/>
                  <a:pt x="1371600" y="3075517"/>
                  <a:pt x="1564217" y="3016250"/>
                </a:cubicBezTo>
                <a:cubicBezTo>
                  <a:pt x="1756834" y="2956983"/>
                  <a:pt x="1988609" y="2798233"/>
                  <a:pt x="2123017" y="2686050"/>
                </a:cubicBezTo>
                <a:cubicBezTo>
                  <a:pt x="2257425" y="2573867"/>
                  <a:pt x="2319867" y="2461683"/>
                  <a:pt x="2370667" y="2343150"/>
                </a:cubicBezTo>
                <a:cubicBezTo>
                  <a:pt x="2421467" y="2224617"/>
                  <a:pt x="2428875" y="2094442"/>
                  <a:pt x="2427817" y="1974850"/>
                </a:cubicBezTo>
                <a:cubicBezTo>
                  <a:pt x="2426759" y="1855258"/>
                  <a:pt x="2396067" y="1747308"/>
                  <a:pt x="2364317" y="1625600"/>
                </a:cubicBezTo>
                <a:cubicBezTo>
                  <a:pt x="2332567" y="1503892"/>
                  <a:pt x="2270125" y="1380067"/>
                  <a:pt x="2237317" y="1244600"/>
                </a:cubicBezTo>
                <a:cubicBezTo>
                  <a:pt x="2204509" y="1109133"/>
                  <a:pt x="2183342" y="945092"/>
                  <a:pt x="2167467" y="812800"/>
                </a:cubicBezTo>
                <a:cubicBezTo>
                  <a:pt x="2151592" y="680508"/>
                  <a:pt x="2156884" y="586317"/>
                  <a:pt x="2142067" y="450850"/>
                </a:cubicBezTo>
                <a:cubicBezTo>
                  <a:pt x="2127250" y="315383"/>
                  <a:pt x="2078567" y="0"/>
                  <a:pt x="2078567" y="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lg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" name="Straight Arrow Connector 13"/>
          <p:cNvCxnSpPr/>
          <p:nvPr/>
        </p:nvCxnSpPr>
        <p:spPr>
          <a:xfrm flipV="1">
            <a:off x="4133714" y="1336245"/>
            <a:ext cx="291038" cy="124255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3858675" y="1336245"/>
            <a:ext cx="305273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M</a:t>
            </a:r>
            <a:endParaRPr lang="en-US" sz="1100" dirty="0">
              <a:solidFill>
                <a:schemeClr val="bg1"/>
              </a:solidFill>
            </a:endParaRPr>
          </a:p>
        </p:txBody>
      </p:sp>
      <p:cxnSp>
        <p:nvCxnSpPr>
          <p:cNvPr id="43" name="Straight Arrow Connector 42"/>
          <p:cNvCxnSpPr/>
          <p:nvPr/>
        </p:nvCxnSpPr>
        <p:spPr>
          <a:xfrm rot="16200000" flipH="1">
            <a:off x="4135804" y="1464760"/>
            <a:ext cx="232507" cy="211287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 rot="16200000" flipH="1">
            <a:off x="3965173" y="1629040"/>
            <a:ext cx="501650" cy="164569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729785" y="1670051"/>
            <a:ext cx="305273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100" dirty="0" smtClean="0"/>
              <a:t>M</a:t>
            </a:r>
            <a:endParaRPr lang="en-US" sz="1100" dirty="0"/>
          </a:p>
        </p:txBody>
      </p:sp>
      <p:cxnSp>
        <p:nvCxnSpPr>
          <p:cNvPr id="48" name="Straight Arrow Connector 47"/>
          <p:cNvCxnSpPr/>
          <p:nvPr/>
        </p:nvCxnSpPr>
        <p:spPr>
          <a:xfrm rot="16200000" flipH="1">
            <a:off x="1868005" y="1952664"/>
            <a:ext cx="219807" cy="101600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rot="5400000">
            <a:off x="1660526" y="1967215"/>
            <a:ext cx="232507" cy="93988"/>
          </a:xfrm>
          <a:prstGeom prst="straightConnector1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Rectangle 52"/>
          <p:cNvSpPr/>
          <p:nvPr/>
        </p:nvSpPr>
        <p:spPr>
          <a:xfrm>
            <a:off x="5361015" y="3378200"/>
            <a:ext cx="897199" cy="2395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Box 53"/>
          <p:cNvSpPr txBox="1"/>
          <p:nvPr/>
        </p:nvSpPr>
        <p:spPr>
          <a:xfrm>
            <a:off x="5297596" y="3327400"/>
            <a:ext cx="10458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FF0000"/>
                </a:solidFill>
              </a:rPr>
              <a:t>SOX10</a:t>
            </a:r>
            <a:r>
              <a:rPr lang="en-US" sz="1400" dirty="0" smtClean="0"/>
              <a:t> </a:t>
            </a:r>
            <a:r>
              <a:rPr lang="en-US" sz="1400" dirty="0" smtClean="0">
                <a:solidFill>
                  <a:srgbClr val="0000FF"/>
                </a:solidFill>
              </a:rPr>
              <a:t>DAPI</a:t>
            </a:r>
            <a:endParaRPr lang="en-US" sz="1400" dirty="0">
              <a:solidFill>
                <a:srgbClr val="0000FF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212737" y="32189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085799" y="-32764"/>
            <a:ext cx="1814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/>
              <a:t>Shakhova</a:t>
            </a:r>
            <a:r>
              <a:rPr lang="en-US" sz="900" dirty="0" smtClean="0"/>
              <a:t> et </a:t>
            </a:r>
            <a:r>
              <a:rPr lang="en-US" sz="900" dirty="0" err="1" smtClean="0"/>
              <a:t>al_Supplemental</a:t>
            </a:r>
            <a:r>
              <a:rPr lang="en-US" sz="900" dirty="0" smtClean="0"/>
              <a:t> Fig</a:t>
            </a:r>
            <a:r>
              <a:rPr lang="en-US" sz="900" dirty="0" smtClean="0"/>
              <a:t>.3</a:t>
            </a:r>
            <a:endParaRPr lang="en-US" sz="9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-232458" y="4796472"/>
            <a:ext cx="21082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UMAN BASAL CELL CARCINOMA</a:t>
            </a:r>
            <a:endParaRPr lang="en-US" sz="1100" dirty="0"/>
          </a:p>
        </p:txBody>
      </p:sp>
      <p:pic>
        <p:nvPicPr>
          <p:cNvPr id="32" name="Picture 31" descr="BCC example 1.tif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7081" y="3746579"/>
            <a:ext cx="2384227" cy="2384227"/>
          </a:xfrm>
          <a:prstGeom prst="rect">
            <a:avLst/>
          </a:prstGeom>
        </p:spPr>
      </p:pic>
      <p:pic>
        <p:nvPicPr>
          <p:cNvPr id="33" name="Picture 32" descr="BCC insert to example 1.tif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80994" y="4266246"/>
            <a:ext cx="1276497" cy="1276497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34" name="TextBox 33"/>
          <p:cNvSpPr txBox="1"/>
          <p:nvPr/>
        </p:nvSpPr>
        <p:spPr>
          <a:xfrm>
            <a:off x="420743" y="35821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5" name="Rectangle 34"/>
          <p:cNvSpPr/>
          <p:nvPr/>
        </p:nvSpPr>
        <p:spPr>
          <a:xfrm>
            <a:off x="2519558" y="5883462"/>
            <a:ext cx="783721" cy="2430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2489828" y="5864412"/>
            <a:ext cx="844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SOX9 </a:t>
            </a:r>
            <a:r>
              <a:rPr lang="en-US" sz="1200" dirty="0" smtClean="0">
                <a:solidFill>
                  <a:srgbClr val="0000FF"/>
                </a:solidFill>
              </a:rPr>
              <a:t>DAPI</a:t>
            </a:r>
            <a:r>
              <a:rPr lang="en-US" sz="1200" dirty="0" smtClean="0">
                <a:solidFill>
                  <a:srgbClr val="FF0000"/>
                </a:solidFill>
              </a:rPr>
              <a:t> </a:t>
            </a:r>
            <a:endParaRPr lang="en-US" sz="1200" dirty="0">
              <a:solidFill>
                <a:srgbClr val="0000FF"/>
              </a:solidFill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270610" y="5481991"/>
            <a:ext cx="4737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chemeClr val="bg1"/>
                </a:solidFill>
              </a:rPr>
              <a:t>BCC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794010" y="4097290"/>
            <a:ext cx="4737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chemeClr val="bg1"/>
                </a:solidFill>
              </a:rPr>
              <a:t>BCC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2162399" y="4896362"/>
            <a:ext cx="302031" cy="298466"/>
          </a:xfrm>
          <a:prstGeom prst="rect">
            <a:avLst/>
          </a:prstGeom>
          <a:noFill/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2" name="Straight Connector 41"/>
          <p:cNvCxnSpPr/>
          <p:nvPr/>
        </p:nvCxnSpPr>
        <p:spPr>
          <a:xfrm flipV="1">
            <a:off x="2464430" y="4405067"/>
            <a:ext cx="838849" cy="491295"/>
          </a:xfrm>
          <a:prstGeom prst="line">
            <a:avLst/>
          </a:prstGeom>
          <a:ln w="9525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2464430" y="5194829"/>
            <a:ext cx="838849" cy="287162"/>
          </a:xfrm>
          <a:prstGeom prst="line">
            <a:avLst/>
          </a:prstGeom>
          <a:ln w="9525" cap="flat" cmpd="sng" algn="ctr">
            <a:solidFill>
              <a:srgbClr val="FFFFFF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V="1">
            <a:off x="3302842" y="4266246"/>
            <a:ext cx="194120" cy="134590"/>
          </a:xfrm>
          <a:prstGeom prst="line">
            <a:avLst/>
          </a:prstGeom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3299046" y="5481991"/>
            <a:ext cx="193683" cy="60752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1" name="Picture 50" descr="SOX9 H08 10533 overlay.tif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42223" y="6233552"/>
            <a:ext cx="2394236" cy="2394236"/>
          </a:xfrm>
          <a:prstGeom prst="rect">
            <a:avLst/>
          </a:prstGeom>
        </p:spPr>
      </p:pic>
      <p:sp>
        <p:nvSpPr>
          <p:cNvPr id="52" name="Freeform 51"/>
          <p:cNvSpPr/>
          <p:nvPr/>
        </p:nvSpPr>
        <p:spPr>
          <a:xfrm>
            <a:off x="4286969" y="6258108"/>
            <a:ext cx="448734" cy="2336800"/>
          </a:xfrm>
          <a:custGeom>
            <a:avLst/>
            <a:gdLst>
              <a:gd name="connsiteX0" fmla="*/ 0 w 448734"/>
              <a:gd name="connsiteY0" fmla="*/ 0 h 2336800"/>
              <a:gd name="connsiteX1" fmla="*/ 143934 w 448734"/>
              <a:gd name="connsiteY1" fmla="*/ 550333 h 2336800"/>
              <a:gd name="connsiteX2" fmla="*/ 169334 w 448734"/>
              <a:gd name="connsiteY2" fmla="*/ 846666 h 2336800"/>
              <a:gd name="connsiteX3" fmla="*/ 237067 w 448734"/>
              <a:gd name="connsiteY3" fmla="*/ 1024466 h 2336800"/>
              <a:gd name="connsiteX4" fmla="*/ 355600 w 448734"/>
              <a:gd name="connsiteY4" fmla="*/ 1532466 h 2336800"/>
              <a:gd name="connsiteX5" fmla="*/ 431800 w 448734"/>
              <a:gd name="connsiteY5" fmla="*/ 2040466 h 2336800"/>
              <a:gd name="connsiteX6" fmla="*/ 448734 w 448734"/>
              <a:gd name="connsiteY6" fmla="*/ 2336800 h 23368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448734" h="2336800">
                <a:moveTo>
                  <a:pt x="0" y="0"/>
                </a:moveTo>
                <a:cubicBezTo>
                  <a:pt x="57856" y="204611"/>
                  <a:pt x="115712" y="409222"/>
                  <a:pt x="143934" y="550333"/>
                </a:cubicBezTo>
                <a:cubicBezTo>
                  <a:pt x="172156" y="691444"/>
                  <a:pt x="153812" y="767644"/>
                  <a:pt x="169334" y="846666"/>
                </a:cubicBezTo>
                <a:cubicBezTo>
                  <a:pt x="184856" y="925688"/>
                  <a:pt x="206023" y="910166"/>
                  <a:pt x="237067" y="1024466"/>
                </a:cubicBezTo>
                <a:cubicBezTo>
                  <a:pt x="268111" y="1138766"/>
                  <a:pt x="323145" y="1363133"/>
                  <a:pt x="355600" y="1532466"/>
                </a:cubicBezTo>
                <a:cubicBezTo>
                  <a:pt x="388056" y="1701799"/>
                  <a:pt x="416278" y="1906410"/>
                  <a:pt x="431800" y="2040466"/>
                </a:cubicBezTo>
                <a:cubicBezTo>
                  <a:pt x="447322" y="2174522"/>
                  <a:pt x="448734" y="2336800"/>
                  <a:pt x="448734" y="2336800"/>
                </a:cubicBezTo>
              </a:path>
            </a:pathLst>
          </a:custGeom>
          <a:ln w="12700" cap="flat" cmpd="sng" algn="ctr">
            <a:solidFill>
              <a:schemeClr val="bg1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Freeform 54"/>
          <p:cNvSpPr/>
          <p:nvPr/>
        </p:nvSpPr>
        <p:spPr>
          <a:xfrm>
            <a:off x="3482636" y="7401108"/>
            <a:ext cx="321733" cy="1219200"/>
          </a:xfrm>
          <a:custGeom>
            <a:avLst/>
            <a:gdLst>
              <a:gd name="connsiteX0" fmla="*/ 0 w 321733"/>
              <a:gd name="connsiteY0" fmla="*/ 0 h 1219200"/>
              <a:gd name="connsiteX1" fmla="*/ 169333 w 321733"/>
              <a:gd name="connsiteY1" fmla="*/ 584200 h 1219200"/>
              <a:gd name="connsiteX2" fmla="*/ 270933 w 321733"/>
              <a:gd name="connsiteY2" fmla="*/ 965200 h 1219200"/>
              <a:gd name="connsiteX3" fmla="*/ 321733 w 321733"/>
              <a:gd name="connsiteY3" fmla="*/ 1219200 h 1219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21733" h="1219200">
                <a:moveTo>
                  <a:pt x="0" y="0"/>
                </a:moveTo>
                <a:cubicBezTo>
                  <a:pt x="62089" y="211666"/>
                  <a:pt x="124178" y="423333"/>
                  <a:pt x="169333" y="584200"/>
                </a:cubicBezTo>
                <a:cubicBezTo>
                  <a:pt x="214488" y="745067"/>
                  <a:pt x="245533" y="859367"/>
                  <a:pt x="270933" y="965200"/>
                </a:cubicBezTo>
                <a:cubicBezTo>
                  <a:pt x="296333" y="1071033"/>
                  <a:pt x="321733" y="1219200"/>
                  <a:pt x="321733" y="1219200"/>
                </a:cubicBezTo>
              </a:path>
            </a:pathLst>
          </a:custGeom>
          <a:ln w="12700" cap="flat" cmpd="sng" algn="ctr">
            <a:solidFill>
              <a:srgbClr val="FFFFFF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/>
          <p:cNvSpPr txBox="1"/>
          <p:nvPr/>
        </p:nvSpPr>
        <p:spPr>
          <a:xfrm>
            <a:off x="5039115" y="7208779"/>
            <a:ext cx="594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GCMN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57" name="Picture 56" descr="SOX10 H08 10533 overlay.tif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12755" y="6225243"/>
            <a:ext cx="2412000" cy="2412000"/>
          </a:xfrm>
          <a:prstGeom prst="rect">
            <a:avLst/>
          </a:prstGeom>
        </p:spPr>
      </p:pic>
      <p:sp>
        <p:nvSpPr>
          <p:cNvPr id="58" name="TextBox 57"/>
          <p:cNvSpPr txBox="1"/>
          <p:nvPr/>
        </p:nvSpPr>
        <p:spPr>
          <a:xfrm>
            <a:off x="856601" y="6167658"/>
            <a:ext cx="1343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FFFF"/>
                </a:solidFill>
              </a:rPr>
              <a:t>patient H08 10533</a:t>
            </a:r>
            <a:endParaRPr lang="en-US" sz="1200" dirty="0">
              <a:solidFill>
                <a:srgbClr val="FFFFFF"/>
              </a:solidFill>
            </a:endParaRPr>
          </a:p>
        </p:txBody>
      </p:sp>
      <p:sp>
        <p:nvSpPr>
          <p:cNvPr id="59" name="Freeform 58"/>
          <p:cNvSpPr/>
          <p:nvPr/>
        </p:nvSpPr>
        <p:spPr>
          <a:xfrm>
            <a:off x="1881071" y="6268561"/>
            <a:ext cx="230011" cy="2353734"/>
          </a:xfrm>
          <a:custGeom>
            <a:avLst/>
            <a:gdLst>
              <a:gd name="connsiteX0" fmla="*/ 0 w 230011"/>
              <a:gd name="connsiteY0" fmla="*/ 0 h 2353734"/>
              <a:gd name="connsiteX1" fmla="*/ 59267 w 230011"/>
              <a:gd name="connsiteY1" fmla="*/ 355600 h 2353734"/>
              <a:gd name="connsiteX2" fmla="*/ 101600 w 230011"/>
              <a:gd name="connsiteY2" fmla="*/ 694267 h 2353734"/>
              <a:gd name="connsiteX3" fmla="*/ 135467 w 230011"/>
              <a:gd name="connsiteY3" fmla="*/ 1134534 h 2353734"/>
              <a:gd name="connsiteX4" fmla="*/ 211667 w 230011"/>
              <a:gd name="connsiteY4" fmla="*/ 1540934 h 2353734"/>
              <a:gd name="connsiteX5" fmla="*/ 194734 w 230011"/>
              <a:gd name="connsiteY5" fmla="*/ 1769534 h 2353734"/>
              <a:gd name="connsiteX6" fmla="*/ 228600 w 230011"/>
              <a:gd name="connsiteY6" fmla="*/ 2116667 h 2353734"/>
              <a:gd name="connsiteX7" fmla="*/ 186267 w 230011"/>
              <a:gd name="connsiteY7" fmla="*/ 2353734 h 23537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230011" h="2353734">
                <a:moveTo>
                  <a:pt x="0" y="0"/>
                </a:moveTo>
                <a:cubicBezTo>
                  <a:pt x="21167" y="119944"/>
                  <a:pt x="42334" y="239889"/>
                  <a:pt x="59267" y="355600"/>
                </a:cubicBezTo>
                <a:cubicBezTo>
                  <a:pt x="76200" y="471311"/>
                  <a:pt x="88900" y="564445"/>
                  <a:pt x="101600" y="694267"/>
                </a:cubicBezTo>
                <a:cubicBezTo>
                  <a:pt x="114300" y="824089"/>
                  <a:pt x="117123" y="993423"/>
                  <a:pt x="135467" y="1134534"/>
                </a:cubicBezTo>
                <a:cubicBezTo>
                  <a:pt x="153811" y="1275645"/>
                  <a:pt x="201789" y="1435101"/>
                  <a:pt x="211667" y="1540934"/>
                </a:cubicBezTo>
                <a:cubicBezTo>
                  <a:pt x="221545" y="1646767"/>
                  <a:pt x="191912" y="1673579"/>
                  <a:pt x="194734" y="1769534"/>
                </a:cubicBezTo>
                <a:cubicBezTo>
                  <a:pt x="197556" y="1865489"/>
                  <a:pt x="230011" y="2019300"/>
                  <a:pt x="228600" y="2116667"/>
                </a:cubicBezTo>
                <a:cubicBezTo>
                  <a:pt x="227189" y="2214034"/>
                  <a:pt x="186267" y="2353734"/>
                  <a:pt x="186267" y="2353734"/>
                </a:cubicBezTo>
              </a:path>
            </a:pathLst>
          </a:custGeom>
          <a:ln w="12700" cap="flat" cmpd="sng" algn="ctr">
            <a:solidFill>
              <a:srgbClr val="FFFFFF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Freeform 59"/>
          <p:cNvSpPr/>
          <p:nvPr/>
        </p:nvSpPr>
        <p:spPr>
          <a:xfrm>
            <a:off x="958205" y="7233761"/>
            <a:ext cx="296333" cy="1388534"/>
          </a:xfrm>
          <a:custGeom>
            <a:avLst/>
            <a:gdLst>
              <a:gd name="connsiteX0" fmla="*/ 0 w 296333"/>
              <a:gd name="connsiteY0" fmla="*/ 0 h 1388534"/>
              <a:gd name="connsiteX1" fmla="*/ 127000 w 296333"/>
              <a:gd name="connsiteY1" fmla="*/ 592667 h 1388534"/>
              <a:gd name="connsiteX2" fmla="*/ 203200 w 296333"/>
              <a:gd name="connsiteY2" fmla="*/ 990600 h 1388534"/>
              <a:gd name="connsiteX3" fmla="*/ 296333 w 296333"/>
              <a:gd name="connsiteY3" fmla="*/ 1388534 h 13885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96333" h="1388534">
                <a:moveTo>
                  <a:pt x="0" y="0"/>
                </a:moveTo>
                <a:cubicBezTo>
                  <a:pt x="46566" y="213783"/>
                  <a:pt x="93133" y="427567"/>
                  <a:pt x="127000" y="592667"/>
                </a:cubicBezTo>
                <a:cubicBezTo>
                  <a:pt x="160867" y="757767"/>
                  <a:pt x="174978" y="857956"/>
                  <a:pt x="203200" y="990600"/>
                </a:cubicBezTo>
                <a:cubicBezTo>
                  <a:pt x="231422" y="1123244"/>
                  <a:pt x="296333" y="1388534"/>
                  <a:pt x="296333" y="1388534"/>
                </a:cubicBezTo>
              </a:path>
            </a:pathLst>
          </a:custGeom>
          <a:ln w="12700" cap="flat" cmpd="sng" algn="ctr">
            <a:solidFill>
              <a:srgbClr val="FFFFFF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/>
          <p:cNvSpPr txBox="1"/>
          <p:nvPr/>
        </p:nvSpPr>
        <p:spPr>
          <a:xfrm>
            <a:off x="2544869" y="7199893"/>
            <a:ext cx="5947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GCMN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005215" y="7324905"/>
            <a:ext cx="101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AIR FOLLICLE</a:t>
            </a:r>
            <a:endParaRPr lang="en-US" sz="1100" dirty="0">
              <a:solidFill>
                <a:schemeClr val="bg1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-360872" y="7262661"/>
            <a:ext cx="23364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HUMAN GIANT CONGENITAL NAEVUS</a:t>
            </a:r>
            <a:endParaRPr lang="en-US" sz="1100" dirty="0"/>
          </a:p>
        </p:txBody>
      </p:sp>
      <p:sp>
        <p:nvSpPr>
          <p:cNvPr id="65" name="TextBox 64"/>
          <p:cNvSpPr txBox="1"/>
          <p:nvPr/>
        </p:nvSpPr>
        <p:spPr>
          <a:xfrm>
            <a:off x="3567306" y="7324905"/>
            <a:ext cx="1012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solidFill>
                  <a:schemeClr val="bg1"/>
                </a:solidFill>
              </a:rPr>
              <a:t>HAIR FOLLICLE</a:t>
            </a:r>
            <a:endParaRPr lang="en-US" sz="1100" dirty="0">
              <a:solidFill>
                <a:schemeClr val="bg1"/>
              </a:solidFill>
            </a:endParaRPr>
          </a:p>
        </p:txBody>
      </p:sp>
      <p:cxnSp>
        <p:nvCxnSpPr>
          <p:cNvPr id="66" name="Straight Arrow Connector 65"/>
          <p:cNvCxnSpPr/>
          <p:nvPr/>
        </p:nvCxnSpPr>
        <p:spPr>
          <a:xfrm rot="5400000" flipH="1" flipV="1">
            <a:off x="1115208" y="6932203"/>
            <a:ext cx="704720" cy="1588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 rot="16200000" flipH="1">
            <a:off x="1115202" y="8049841"/>
            <a:ext cx="704720" cy="1588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/>
          <p:nvPr/>
        </p:nvCxnSpPr>
        <p:spPr>
          <a:xfrm rot="5400000" flipH="1" flipV="1">
            <a:off x="3664746" y="6905113"/>
            <a:ext cx="704720" cy="1588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 rot="16200000" flipH="1">
            <a:off x="3664740" y="8022751"/>
            <a:ext cx="704720" cy="1588"/>
          </a:xfrm>
          <a:prstGeom prst="straightConnector1">
            <a:avLst/>
          </a:prstGeom>
          <a:ln w="12700" cap="flat" cmpd="sng" algn="ctr">
            <a:solidFill>
              <a:srgbClr val="FFFFFF"/>
            </a:solidFill>
            <a:prstDash val="solid"/>
            <a:round/>
            <a:headEnd type="none" w="med" len="med"/>
            <a:tailEnd type="triangle" w="med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392409" y="6038929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71" name="TextBox 70"/>
          <p:cNvSpPr txBox="1"/>
          <p:nvPr/>
        </p:nvSpPr>
        <p:spPr>
          <a:xfrm>
            <a:off x="3391421" y="6181558"/>
            <a:ext cx="1343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FFFF"/>
                </a:solidFill>
              </a:rPr>
              <a:t>patient H08 10533</a:t>
            </a:r>
            <a:endParaRPr lang="en-US" sz="1200" dirty="0">
              <a:solidFill>
                <a:srgbClr val="FFFFFF"/>
              </a:solidFill>
            </a:endParaRPr>
          </a:p>
        </p:txBody>
      </p:sp>
      <p:sp>
        <p:nvSpPr>
          <p:cNvPr id="72" name="Rectangle 71"/>
          <p:cNvSpPr/>
          <p:nvPr/>
        </p:nvSpPr>
        <p:spPr>
          <a:xfrm>
            <a:off x="5043444" y="8379294"/>
            <a:ext cx="783721" cy="2430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TextBox 72"/>
          <p:cNvSpPr txBox="1"/>
          <p:nvPr/>
        </p:nvSpPr>
        <p:spPr>
          <a:xfrm>
            <a:off x="5013714" y="8360244"/>
            <a:ext cx="844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SOX9 </a:t>
            </a:r>
            <a:r>
              <a:rPr lang="en-US" sz="1200" dirty="0" smtClean="0">
                <a:solidFill>
                  <a:srgbClr val="0000FF"/>
                </a:solidFill>
              </a:rPr>
              <a:t>DAPI</a:t>
            </a:r>
            <a:r>
              <a:rPr lang="en-US" sz="1200" dirty="0" smtClean="0">
                <a:solidFill>
                  <a:srgbClr val="FF0000"/>
                </a:solidFill>
              </a:rPr>
              <a:t> </a:t>
            </a:r>
            <a:endParaRPr lang="en-US" sz="1200" dirty="0">
              <a:solidFill>
                <a:srgbClr val="0000FF"/>
              </a:solidFill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2545800" y="8393194"/>
            <a:ext cx="783721" cy="2430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TextBox 74"/>
          <p:cNvSpPr txBox="1"/>
          <p:nvPr/>
        </p:nvSpPr>
        <p:spPr>
          <a:xfrm>
            <a:off x="2482202" y="8365677"/>
            <a:ext cx="9228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SOX10 </a:t>
            </a:r>
            <a:r>
              <a:rPr lang="en-US" sz="1200" dirty="0" smtClean="0">
                <a:solidFill>
                  <a:srgbClr val="0000FF"/>
                </a:solidFill>
              </a:rPr>
              <a:t>DAPI</a:t>
            </a:r>
            <a:r>
              <a:rPr lang="en-US" sz="1200" dirty="0" smtClean="0">
                <a:solidFill>
                  <a:srgbClr val="FF0000"/>
                </a:solidFill>
              </a:rPr>
              <a:t> </a:t>
            </a:r>
            <a:endParaRPr lang="en-US" sz="1200" dirty="0">
              <a:solidFill>
                <a:srgbClr val="0000FF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54</Words>
  <Application>Microsoft Macintosh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lga Shakhova</dc:creator>
  <cp:lastModifiedBy>Olga Shakhova</cp:lastModifiedBy>
  <cp:revision>6</cp:revision>
  <dcterms:created xsi:type="dcterms:W3CDTF">2014-09-16T13:17:52Z</dcterms:created>
  <dcterms:modified xsi:type="dcterms:W3CDTF">2014-09-16T13:18:32Z</dcterms:modified>
</cp:coreProperties>
</file>